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4" r:id="rId2"/>
    <p:sldId id="277" r:id="rId3"/>
    <p:sldId id="276" r:id="rId4"/>
    <p:sldId id="275" r:id="rId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2" d="100"/>
          <a:sy n="82" d="100"/>
        </p:scale>
        <p:origin x="60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w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w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402AD3C-394E-49A3-9147-6BD66F17B29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120E628-2D02-496F-8B83-AAF64AA4D74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325F44B-F805-487F-8753-E9D0C574A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44946CB-2498-40A6-B4FE-7F37942EF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24FDBAD-6648-4B8A-B105-37422F29DC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06474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C298C22-649B-4C97-A7E0-B911072E40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2769C2F-2CFA-4D4A-A995-21C89A5814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0784A9A-49B7-45FC-8E72-0010288DD0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919D129-4811-4EF6-8DD4-61D477CD9B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D282712-A51E-48DC-A424-7264E78106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61809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F50EF414-7458-42B0-83F2-DB3D454A1F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E59A1B9E-6550-41A0-93A5-BFB366DBF34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623B468-ECAD-47E1-8992-72AA689D2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9F7DD2DF-4DA4-41DA-939B-E4E8A32CF0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12954A0-9DC9-4AC6-873E-3864428EE9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8412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036F17F-6F29-48AF-A455-F479AA055E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F2F92BA-8530-4392-A54C-A67391D9FF2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9AE42063-BD70-4361-9CD7-F0B2A0DC8A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363198D-1BDE-48D5-9076-C439C2B8CE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2864D17-18BD-4531-AEAF-BE2D424DC8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5430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FAC8C5FB-AFFE-4BD4-89F9-ECF02F2050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D72E339-EDED-4FD9-8C9C-3DA58596120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9AC4B8F-BCD6-451C-A5C9-AC6A8485DC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060A473-E371-4337-A538-147B4690C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9432B6DF-C4F4-4054-AAA3-83771764A3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12308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6655C35-8D92-4958-AB10-534156AF11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BC3175E-3AB6-4FCB-941B-EFBEF0B9E13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91637E2A-90EA-4B7E-AF77-476AF6DD832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E0D7A78-6C45-4906-B7FE-DE2DBC8183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451239B-3F4F-41BE-91BE-AFA4ACBFA3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38E54339-495A-4ADA-A567-9F7EE381F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06265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A1C8F53-4705-42D8-8ED2-E3A694E9E6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105C3783-8B46-4A5B-B6D8-515F98F29B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C2616131-8D28-40AB-AD01-A9B87E52D1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0A125B0B-415A-42A9-A7BB-BEEAA94A708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4C15B5EE-5AF3-46DE-8A59-F55AFBA3ED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86AC37A-75FF-4F43-99EE-35B6B2B56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0C89456-F544-4F07-A7EC-3B03B5E06E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4174E6A7-7B7B-457D-A4D9-AD814826AC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0031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EF246FE-944D-4E32-A648-11EEF03BF4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AFB6EA6A-DAA9-4096-AD9D-C65BDE25D6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398CCFE4-EA76-4528-9F3A-9B95B9CDA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441CF767-31EB-457F-9B40-EA4C140B7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1429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0951778-409B-474D-BEA5-2438823FA6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4240265F-91EB-4DBC-81B6-6FBD4C6B48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366C24A6-1928-4A99-9D79-64636596B5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552382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55FA951-6FBB-4756-8DEF-9A3B20B0C2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E2240A4-9435-48C3-889F-F4C720177B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6587056B-A0EB-4C52-A405-8E9E93AA36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1C0CA0E-3E96-4000-AE74-0A74AA0B7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1AC55C1-0FE7-4CDF-BB5C-4C1240C4B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6B792F4-52B8-4BBF-AFA0-9987ED7171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73244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F837F0A-8604-4802-A809-B15F73FB3E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CB8BF89E-AEE6-423C-A0C9-85A677F84EE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59ACFE0-F09F-459D-A65B-DFF61F7C08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E19FEB57-C9A9-4A63-A7D5-62A787690F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98CC02BF-AFE6-465E-A15D-EB30170719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43E6394-C794-476F-AA2B-FC5521D6F1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2843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3BA6C1BF-8E60-48EF-9677-AAF382C46B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6A55B60-9FFA-4B13-911F-358FADFA6C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A1AEADF-62AD-4602-A37E-B2199BE19EE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6D10A9-143D-4A44-AB5F-5A81B98E3142}" type="datetimeFigureOut">
              <a:rPr lang="ko-KR" altLang="en-US" smtClean="0"/>
              <a:t>2023-11-25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6DFB0CD-EBAF-4FF0-8F77-5BB73ACE92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5259AEF-24C6-4C2C-81FC-8B5A6077527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327721-50C0-4511-9BE5-5C921E5B58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61161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w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4" Type="http://schemas.openxmlformats.org/officeDocument/2006/relationships/image" Target="../media/image3.w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4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개체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2801317"/>
              </p:ext>
            </p:extLst>
          </p:nvPr>
        </p:nvGraphicFramePr>
        <p:xfrm>
          <a:off x="1658046" y="329021"/>
          <a:ext cx="8875907" cy="6199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Graph" r:id="rId3" imgW="4154760" imgH="2901600" progId="Origin50.Graph">
                  <p:embed/>
                </p:oleObj>
              </mc:Choice>
              <mc:Fallback>
                <p:oleObj name="Graph" r:id="rId3" imgW="4154760" imgH="2901600" progId="Origin50.Graph">
                  <p:embed/>
                  <p:pic>
                    <p:nvPicPr>
                      <p:cNvPr id="5" name="개체 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58046" y="329021"/>
                        <a:ext cx="8875907" cy="6199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직사각형 18"/>
          <p:cNvSpPr/>
          <p:nvPr/>
        </p:nvSpPr>
        <p:spPr>
          <a:xfrm>
            <a:off x="3237117" y="1024189"/>
            <a:ext cx="52610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b="1" dirty="0">
                <a:latin typeface="Times New Roman" panose="02020603050405020304" pitchFamily="18" charset="0"/>
              </a:rPr>
              <a:t>a)</a:t>
            </a:r>
            <a:endParaRPr lang="ko-KR" altLang="en-US" sz="3200" b="1" dirty="0"/>
          </a:p>
        </p:txBody>
      </p:sp>
      <p:grpSp>
        <p:nvGrpSpPr>
          <p:cNvPr id="20" name="그룹 19"/>
          <p:cNvGrpSpPr/>
          <p:nvPr/>
        </p:nvGrpSpPr>
        <p:grpSpPr>
          <a:xfrm>
            <a:off x="4176015" y="1935702"/>
            <a:ext cx="4517745" cy="2193682"/>
            <a:chOff x="1899471" y="388682"/>
            <a:chExt cx="4517745" cy="2193682"/>
          </a:xfrm>
        </p:grpSpPr>
        <p:sp>
          <p:nvSpPr>
            <p:cNvPr id="21" name="직사각형 20"/>
            <p:cNvSpPr/>
            <p:nvPr/>
          </p:nvSpPr>
          <p:spPr>
            <a:xfrm>
              <a:off x="3020132" y="1203772"/>
              <a:ext cx="3397084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Data correction for </a:t>
              </a:r>
              <a:r>
                <a:rPr lang="en-US" altLang="ko-KR" dirty="0" err="1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amorphization</a:t>
              </a:r>
              <a:r>
                <a:rPr lang="en-US" altLang="ko-KR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:</a:t>
              </a:r>
            </a:p>
            <a:p>
              <a:pPr algn="ctr"/>
              <a:r>
                <a:rPr lang="en-US" altLang="ko-KR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γ-</a:t>
              </a:r>
              <a:r>
                <a:rPr lang="en-GB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g(BH</a:t>
              </a:r>
              <a:r>
                <a:rPr lang="en-GB" altLang="ko-KR" b="1" baseline="-25000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GB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)</a:t>
              </a:r>
              <a:r>
                <a:rPr lang="en-GB" altLang="ko-KR" b="1" baseline="-25000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 </a:t>
              </a:r>
              <a:r>
                <a:rPr lang="en-GB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‧2.04H</a:t>
              </a:r>
              <a:r>
                <a:rPr lang="en-GB" altLang="ko-KR" b="1" baseline="-25000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GB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ko-KR" altLang="en-US" b="1" dirty="0">
                <a:solidFill>
                  <a:srgbClr val="0000FF"/>
                </a:solidFill>
              </a:endParaRPr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2458803" y="388682"/>
              <a:ext cx="2432076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GB" altLang="ko-KR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H</a:t>
              </a:r>
              <a:r>
                <a:rPr lang="en-GB" altLang="ko-KR" baseline="-250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GB" altLang="ko-KR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uptake ~ ca. 4.2 </a:t>
              </a:r>
              <a:r>
                <a:rPr lang="en-GB" altLang="ko-KR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wt</a:t>
              </a:r>
              <a:r>
                <a:rPr lang="en-GB" altLang="ko-KR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%</a:t>
              </a:r>
              <a:endPara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아래쪽 화살표 22"/>
            <p:cNvSpPr/>
            <p:nvPr/>
          </p:nvSpPr>
          <p:spPr>
            <a:xfrm>
              <a:off x="4079187" y="766560"/>
              <a:ext cx="401653" cy="543040"/>
            </a:xfrm>
            <a:prstGeom prst="downArrow">
              <a:avLst/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4" name="직사각형 23"/>
            <p:cNvSpPr/>
            <p:nvPr/>
          </p:nvSpPr>
          <p:spPr>
            <a:xfrm>
              <a:off x="1899471" y="2213032"/>
              <a:ext cx="448392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γ-</a:t>
              </a:r>
              <a:r>
                <a:rPr lang="en-GB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g(BH</a:t>
              </a:r>
              <a:r>
                <a:rPr lang="en-GB" altLang="ko-KR" baseline="-2500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GB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)</a:t>
              </a:r>
              <a:r>
                <a:rPr lang="en-GB" altLang="ko-KR" baseline="-2500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 </a:t>
              </a:r>
              <a:r>
                <a:rPr lang="en-GB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‧</a:t>
              </a:r>
              <a:r>
                <a:rPr lang="en-GB" altLang="ko-KR" b="1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0.38N</a:t>
              </a:r>
              <a:r>
                <a:rPr lang="en-GB" altLang="ko-KR" b="1" baseline="-2500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GB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~ </a:t>
              </a:r>
              <a:r>
                <a:rPr lang="en-GB" altLang="ko-KR" b="1" u="sng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ca. 42% </a:t>
              </a:r>
              <a:r>
                <a:rPr lang="en-GB" altLang="ko-KR" u="sng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orphization</a:t>
              </a:r>
              <a:endParaRPr lang="ko-KR" altLang="en-US" b="1" u="sng" dirty="0">
                <a:solidFill>
                  <a:srgbClr val="FF0000"/>
                </a:solidFill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27221ECA-1709-4029-9B0D-D1A1C2E97DED}"/>
              </a:ext>
            </a:extLst>
          </p:cNvPr>
          <p:cNvSpPr txBox="1"/>
          <p:nvPr/>
        </p:nvSpPr>
        <p:spPr>
          <a:xfrm>
            <a:off x="9330" y="0"/>
            <a:ext cx="1039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Figure 4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9135452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47168586"/>
              </p:ext>
            </p:extLst>
          </p:nvPr>
        </p:nvGraphicFramePr>
        <p:xfrm>
          <a:off x="1467324" y="324123"/>
          <a:ext cx="8890002" cy="62097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Graph" r:id="rId3" imgW="4154760" imgH="2901600" progId="Origin50.Graph">
                  <p:embed/>
                </p:oleObj>
              </mc:Choice>
              <mc:Fallback>
                <p:oleObj name="Graph" r:id="rId3" imgW="4154760" imgH="2901600" progId="Origin50.Graph">
                  <p:embed/>
                  <p:pic>
                    <p:nvPicPr>
                      <p:cNvPr id="4" name="개체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67324" y="324123"/>
                        <a:ext cx="8890002" cy="62097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7" name="그룹 16"/>
          <p:cNvGrpSpPr/>
          <p:nvPr/>
        </p:nvGrpSpPr>
        <p:grpSpPr>
          <a:xfrm>
            <a:off x="3917391" y="1445419"/>
            <a:ext cx="4483921" cy="3343021"/>
            <a:chOff x="1899471" y="-760657"/>
            <a:chExt cx="4483921" cy="3343021"/>
          </a:xfrm>
        </p:grpSpPr>
        <p:sp>
          <p:nvSpPr>
            <p:cNvPr id="6" name="직사각형 5"/>
            <p:cNvSpPr/>
            <p:nvPr/>
          </p:nvSpPr>
          <p:spPr>
            <a:xfrm>
              <a:off x="2254685" y="-760657"/>
              <a:ext cx="3397084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Data correction for </a:t>
              </a:r>
              <a:r>
                <a:rPr lang="en-US" altLang="ko-KR" dirty="0" err="1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amorphization</a:t>
              </a:r>
              <a:r>
                <a:rPr lang="en-US" altLang="ko-KR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:</a:t>
              </a:r>
            </a:p>
            <a:p>
              <a:r>
                <a:rPr lang="en-US" altLang="ko-KR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r>
                <a:rPr lang="en-US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γ-</a:t>
              </a:r>
              <a:r>
                <a:rPr lang="en-GB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g(BH</a:t>
              </a:r>
              <a:r>
                <a:rPr lang="en-GB" altLang="ko-KR" b="1" baseline="-25000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GB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)</a:t>
              </a:r>
              <a:r>
                <a:rPr lang="en-GB" altLang="ko-KR" b="1" baseline="-25000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 </a:t>
              </a:r>
              <a:r>
                <a:rPr lang="en-GB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‧2.06H</a:t>
              </a:r>
              <a:r>
                <a:rPr lang="en-GB" altLang="ko-KR" b="1" baseline="-25000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GB" altLang="ko-KR" b="1" dirty="0">
                  <a:solidFill>
                    <a:srgbClr val="0000FF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</a:t>
              </a:r>
              <a:endParaRPr lang="ko-KR" altLang="en-US" b="1" dirty="0">
                <a:solidFill>
                  <a:srgbClr val="0000FF"/>
                </a:solidFill>
              </a:endParaRPr>
            </a:p>
          </p:txBody>
        </p:sp>
        <p:sp>
          <p:nvSpPr>
            <p:cNvPr id="7" name="직사각형 6"/>
            <p:cNvSpPr/>
            <p:nvPr/>
          </p:nvSpPr>
          <p:spPr>
            <a:xfrm>
              <a:off x="2254685" y="703470"/>
              <a:ext cx="2470548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GB" altLang="ko-KR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H</a:t>
              </a:r>
              <a:r>
                <a:rPr lang="en-GB" altLang="ko-KR" baseline="-25000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GB" altLang="ko-KR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 uptake ~ ca. 2.8 </a:t>
              </a:r>
              <a:r>
                <a:rPr lang="en-GB" altLang="ko-KR" dirty="0" err="1">
                  <a:latin typeface="Times New Roman" panose="02020603050405020304" pitchFamily="18" charset="0"/>
                  <a:ea typeface="Times New Roman" panose="02020603050405020304" pitchFamily="18" charset="0"/>
                </a:rPr>
                <a:t>wt</a:t>
              </a:r>
              <a:r>
                <a:rPr lang="en-GB" altLang="ko-KR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%</a:t>
              </a:r>
              <a:endParaRPr lang="en-GB" altLang="ko-KR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아래쪽 화살표 7"/>
            <p:cNvSpPr/>
            <p:nvPr/>
          </p:nvSpPr>
          <p:spPr>
            <a:xfrm flipV="1">
              <a:off x="2996219" y="-35176"/>
              <a:ext cx="401653" cy="732746"/>
            </a:xfrm>
            <a:prstGeom prst="downArrow">
              <a:avLst/>
            </a:prstGeom>
            <a:solidFill>
              <a:schemeClr val="accent1">
                <a:alpha val="50000"/>
              </a:schemeClr>
            </a:solidFill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9" name="직사각형 8"/>
            <p:cNvSpPr/>
            <p:nvPr/>
          </p:nvSpPr>
          <p:spPr>
            <a:xfrm>
              <a:off x="1899471" y="2213032"/>
              <a:ext cx="4483921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r"/>
              <a:r>
                <a:rPr lang="en-US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γ-</a:t>
              </a:r>
              <a:r>
                <a:rPr lang="en-GB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Mg(BH</a:t>
              </a:r>
              <a:r>
                <a:rPr lang="en-GB" altLang="ko-KR" baseline="-2500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4</a:t>
              </a:r>
              <a:r>
                <a:rPr lang="en-GB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)</a:t>
              </a:r>
              <a:r>
                <a:rPr lang="en-GB" altLang="ko-KR" baseline="-2500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 </a:t>
              </a:r>
              <a:r>
                <a:rPr lang="en-GB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‧</a:t>
              </a:r>
              <a:r>
                <a:rPr lang="en-GB" altLang="ko-KR" b="1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0.25N</a:t>
              </a:r>
              <a:r>
                <a:rPr lang="en-GB" altLang="ko-KR" b="1" baseline="-25000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2</a:t>
              </a:r>
              <a:r>
                <a:rPr lang="en-GB" altLang="ko-KR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 ~ </a:t>
              </a:r>
              <a:r>
                <a:rPr lang="en-GB" altLang="ko-KR" b="1" u="sng" dirty="0">
                  <a:solidFill>
                    <a:srgbClr val="FF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</a:rPr>
                <a:t>ca. 62% </a:t>
              </a:r>
              <a:r>
                <a:rPr lang="en-GB" altLang="ko-KR" u="sng" dirty="0" err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morphization</a:t>
              </a:r>
              <a:endParaRPr lang="ko-KR" altLang="en-US" b="1" u="sng" dirty="0">
                <a:solidFill>
                  <a:srgbClr val="FF0000"/>
                </a:solidFill>
              </a:endParaRPr>
            </a:p>
          </p:txBody>
        </p:sp>
      </p:grpSp>
      <p:sp>
        <p:nvSpPr>
          <p:cNvPr id="18" name="직사각형 17"/>
          <p:cNvSpPr/>
          <p:nvPr/>
        </p:nvSpPr>
        <p:spPr>
          <a:xfrm>
            <a:off x="3060490" y="1042809"/>
            <a:ext cx="548548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b="1" dirty="0">
                <a:latin typeface="Times New Roman" panose="02020603050405020304" pitchFamily="18" charset="0"/>
              </a:rPr>
              <a:t>b)</a:t>
            </a:r>
            <a:endParaRPr lang="ko-KR" altLang="en-US" sz="3200" b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7200AC0-1959-4580-98CE-0D0C98BB8CAC}"/>
              </a:ext>
            </a:extLst>
          </p:cNvPr>
          <p:cNvSpPr txBox="1"/>
          <p:nvPr/>
        </p:nvSpPr>
        <p:spPr>
          <a:xfrm>
            <a:off x="9330" y="0"/>
            <a:ext cx="1039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Figure 4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9869825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개체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0149241"/>
              </p:ext>
            </p:extLst>
          </p:nvPr>
        </p:nvGraphicFramePr>
        <p:xfrm>
          <a:off x="1320382" y="336201"/>
          <a:ext cx="9336732" cy="65217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4" name="Graph" r:id="rId3" imgW="4154760" imgH="2901600" progId="Origin50.Graph">
                  <p:embed/>
                </p:oleObj>
              </mc:Choice>
              <mc:Fallback>
                <p:oleObj name="Graph" r:id="rId3" imgW="4154760" imgH="2901600" progId="Origin50.Graph">
                  <p:embed/>
                  <p:pic>
                    <p:nvPicPr>
                      <p:cNvPr id="7" name="개체 6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20382" y="336201"/>
                        <a:ext cx="9336732" cy="65217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직사각형 7"/>
          <p:cNvSpPr/>
          <p:nvPr/>
        </p:nvSpPr>
        <p:spPr>
          <a:xfrm>
            <a:off x="8783654" y="1084142"/>
            <a:ext cx="526106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b="1" dirty="0">
                <a:latin typeface="Times New Roman" panose="02020603050405020304" pitchFamily="18" charset="0"/>
              </a:rPr>
              <a:t>a)</a:t>
            </a:r>
            <a:endParaRPr lang="ko-KR" altLang="en-US" sz="3200" b="1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B8618AC-A4FF-48D7-8C5A-5761068D0FB3}"/>
              </a:ext>
            </a:extLst>
          </p:cNvPr>
          <p:cNvSpPr txBox="1"/>
          <p:nvPr/>
        </p:nvSpPr>
        <p:spPr>
          <a:xfrm>
            <a:off x="9330" y="0"/>
            <a:ext cx="1039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dirty="0"/>
              <a:t>Figure 5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6365603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개체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02452769"/>
              </p:ext>
            </p:extLst>
          </p:nvPr>
        </p:nvGraphicFramePr>
        <p:xfrm>
          <a:off x="1274803" y="164534"/>
          <a:ext cx="9343373" cy="65289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098" name="Graph" r:id="rId3" imgW="4153680" imgH="2901600" progId="Origin50.Graph">
                  <p:embed/>
                </p:oleObj>
              </mc:Choice>
              <mc:Fallback>
                <p:oleObj name="Graph" r:id="rId3" imgW="4153680" imgH="2901600" progId="Origin50.Graph">
                  <p:embed/>
                  <p:pic>
                    <p:nvPicPr>
                      <p:cNvPr id="4" name="개체 3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74803" y="164534"/>
                        <a:ext cx="9343373" cy="65289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직사각형 8"/>
          <p:cNvSpPr/>
          <p:nvPr/>
        </p:nvSpPr>
        <p:spPr>
          <a:xfrm>
            <a:off x="8542673" y="912502"/>
            <a:ext cx="548548" cy="58477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3200" b="1" dirty="0">
                <a:latin typeface="Times New Roman" panose="02020603050405020304" pitchFamily="18" charset="0"/>
              </a:rPr>
              <a:t>b)</a:t>
            </a:r>
            <a:endParaRPr lang="ko-KR" altLang="en-US" sz="3200" b="1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AEEF6B6-2CCD-424A-9674-FF62F2BE2285}"/>
              </a:ext>
            </a:extLst>
          </p:cNvPr>
          <p:cNvSpPr txBox="1"/>
          <p:nvPr/>
        </p:nvSpPr>
        <p:spPr>
          <a:xfrm>
            <a:off x="9330" y="0"/>
            <a:ext cx="10390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/>
              <a:t>Figure 5</a:t>
            </a:r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804817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80</Words>
  <Application>Microsoft Office PowerPoint</Application>
  <PresentationFormat>와이드스크린</PresentationFormat>
  <Paragraphs>16</Paragraphs>
  <Slides>4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Times New Roman</vt:lpstr>
      <vt:lpstr>Office 테마</vt:lpstr>
      <vt:lpstr>Graph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oh hyunchul</dc:creator>
  <cp:lastModifiedBy>hyunchul oh</cp:lastModifiedBy>
  <cp:revision>9</cp:revision>
  <dcterms:created xsi:type="dcterms:W3CDTF">2023-11-24T00:23:47Z</dcterms:created>
  <dcterms:modified xsi:type="dcterms:W3CDTF">2023-11-25T04:00:23Z</dcterms:modified>
</cp:coreProperties>
</file>